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 type="screen4x3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37"/>
  </p:normalViewPr>
  <p:slideViewPr>
    <p:cSldViewPr snapToGrid="0">
      <p:cViewPr>
        <p:scale>
          <a:sx n="128" d="100"/>
          <a:sy n="128" d="100"/>
        </p:scale>
        <p:origin x="4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 b="0" strike="noStrike" spc="-1">
                <a:solidFill>
                  <a:srgbClr val="000000"/>
                </a:solidFill>
                <a:latin typeface="Calibri"/>
              </a:rPr>
              <a:t>Click to edit Master title style</a:t>
            </a:r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9095839F-83FF-491A-8D9D-53167052747E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8/28/21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3C7BB6EA-2207-4D1A-9AC2-88539AB56793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58C009F2-DE28-4C7C-94F9-2FB66E7C8472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8/28/21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3253BAF8-C6CE-445D-8952-7A603F90B9B6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2"/>
          <p:cNvPicPr/>
          <p:nvPr/>
        </p:nvPicPr>
        <p:blipFill>
          <a:blip r:embed="rId2"/>
          <a:stretch/>
        </p:blipFill>
        <p:spPr>
          <a:xfrm>
            <a:off x="1161489" y="1196639"/>
            <a:ext cx="7164360" cy="4819149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84" name="TextShape 2"/>
          <p:cNvSpPr txBox="1"/>
          <p:nvPr/>
        </p:nvSpPr>
        <p:spPr>
          <a:xfrm>
            <a:off x="2323778" y="40685"/>
            <a:ext cx="4496444" cy="3463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z="1800" b="0" strike="noStrike" spc="-1" dirty="0">
                <a:latin typeface="Arial"/>
              </a:rPr>
              <a:t>Source data related to Main Figure 1c</a:t>
            </a:r>
          </a:p>
        </p:txBody>
      </p:sp>
      <p:sp>
        <p:nvSpPr>
          <p:cNvPr id="2" name="Rectangle 1"/>
          <p:cNvSpPr/>
          <p:nvPr/>
        </p:nvSpPr>
        <p:spPr>
          <a:xfrm>
            <a:off x="5667259" y="2692064"/>
            <a:ext cx="1139538" cy="52167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4" name="Straight Connector 3"/>
          <p:cNvCxnSpPr/>
          <p:nvPr/>
        </p:nvCxnSpPr>
        <p:spPr>
          <a:xfrm flipH="1" flipV="1">
            <a:off x="1078475" y="3068865"/>
            <a:ext cx="516965" cy="1631"/>
          </a:xfrm>
          <a:prstGeom prst="line">
            <a:avLst/>
          </a:prstGeom>
          <a:ln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 flipV="1">
            <a:off x="1078474" y="2922930"/>
            <a:ext cx="516965" cy="1631"/>
          </a:xfrm>
          <a:prstGeom prst="line">
            <a:avLst/>
          </a:prstGeom>
          <a:ln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 flipV="1">
            <a:off x="1078474" y="2802657"/>
            <a:ext cx="516965" cy="1631"/>
          </a:xfrm>
          <a:prstGeom prst="line">
            <a:avLst/>
          </a:prstGeom>
          <a:ln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639918" y="2680189"/>
            <a:ext cx="543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00bp</a:t>
            </a:r>
            <a:endParaRPr lang="en-IN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642125" y="2815207"/>
            <a:ext cx="543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50bp</a:t>
            </a:r>
            <a:endParaRPr lang="en-IN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642124" y="2955002"/>
            <a:ext cx="543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00bp</a:t>
            </a:r>
            <a:endParaRPr lang="en-IN" sz="8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C79C9D5-75DD-594B-B233-86EA750DEB0A}"/>
              </a:ext>
            </a:extLst>
          </p:cNvPr>
          <p:cNvGrpSpPr/>
          <p:nvPr/>
        </p:nvGrpSpPr>
        <p:grpSpPr>
          <a:xfrm>
            <a:off x="5478871" y="986607"/>
            <a:ext cx="1492564" cy="348813"/>
            <a:chOff x="1806980" y="965807"/>
            <a:chExt cx="1356876" cy="348813"/>
          </a:xfrm>
        </p:grpSpPr>
        <p:sp>
          <p:nvSpPr>
            <p:cNvPr id="6" name="TextBox 5"/>
            <p:cNvSpPr txBox="1"/>
            <p:nvPr/>
          </p:nvSpPr>
          <p:spPr>
            <a:xfrm>
              <a:off x="1806980" y="965807"/>
              <a:ext cx="595424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satb2</a:t>
              </a:r>
              <a:r>
                <a:rPr lang="en-US" sz="1000" baseline="30000" dirty="0"/>
                <a:t>+/+</a:t>
              </a:r>
              <a:endParaRPr lang="en-IN" sz="1000" baseline="30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87706" y="965807"/>
              <a:ext cx="5954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satb2</a:t>
              </a:r>
              <a:r>
                <a:rPr lang="en-US" sz="1000" baseline="30000" dirty="0"/>
                <a:t>+/-</a:t>
              </a:r>
              <a:endParaRPr lang="en-IN" sz="1000" baseline="30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568432" y="965807"/>
              <a:ext cx="5954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satb2</a:t>
              </a:r>
              <a:r>
                <a:rPr lang="en-US" sz="1000" baseline="30000" dirty="0"/>
                <a:t>-/-</a:t>
              </a:r>
              <a:endParaRPr lang="en-IN" sz="1000" baseline="30000" dirty="0"/>
            </a:p>
          </p:txBody>
        </p:sp>
      </p:grpSp>
      <p:sp>
        <p:nvSpPr>
          <p:cNvPr id="17" name="TextShape 2">
            <a:extLst>
              <a:ext uri="{FF2B5EF4-FFF2-40B4-BE49-F238E27FC236}">
                <a16:creationId xmlns:a16="http://schemas.microsoft.com/office/drawing/2014/main" id="{68FB12B2-ED12-7B4F-BFAD-CA7EAC6612A8}"/>
              </a:ext>
            </a:extLst>
          </p:cNvPr>
          <p:cNvSpPr txBox="1"/>
          <p:nvPr/>
        </p:nvSpPr>
        <p:spPr>
          <a:xfrm>
            <a:off x="2056192" y="6225820"/>
            <a:ext cx="5116503" cy="286215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z="1800" b="0" strike="noStrike" spc="-1" dirty="0">
                <a:latin typeface="Arial"/>
              </a:rPr>
              <a:t>Box highlights data represented in Main figure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2"/>
          <p:cNvPicPr/>
          <p:nvPr/>
        </p:nvPicPr>
        <p:blipFill>
          <a:blip r:embed="rId2"/>
          <a:stretch/>
        </p:blipFill>
        <p:spPr>
          <a:xfrm flipH="1">
            <a:off x="2291400" y="1045031"/>
            <a:ext cx="4566600" cy="182880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86" name="Picture 3"/>
          <p:cNvPicPr/>
          <p:nvPr/>
        </p:nvPicPr>
        <p:blipFill>
          <a:blip r:embed="rId3"/>
          <a:stretch/>
        </p:blipFill>
        <p:spPr>
          <a:xfrm flipH="1">
            <a:off x="2306520" y="4159436"/>
            <a:ext cx="4551480" cy="1430280"/>
          </a:xfrm>
          <a:prstGeom prst="rect">
            <a:avLst/>
          </a:prstGeom>
          <a:solidFill>
            <a:srgbClr val="FFFFFF"/>
          </a:solidFill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87" name="CustomShape 1"/>
          <p:cNvSpPr/>
          <p:nvPr/>
        </p:nvSpPr>
        <p:spPr>
          <a:xfrm>
            <a:off x="6386220" y="2062188"/>
            <a:ext cx="195048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SATB2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88" name="CustomShape 2"/>
          <p:cNvSpPr/>
          <p:nvPr/>
        </p:nvSpPr>
        <p:spPr>
          <a:xfrm>
            <a:off x="6478967" y="4208606"/>
            <a:ext cx="203292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Tubulin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89" name="TextShape 3"/>
          <p:cNvSpPr txBox="1"/>
          <p:nvPr/>
        </p:nvSpPr>
        <p:spPr>
          <a:xfrm>
            <a:off x="2820060" y="0"/>
            <a:ext cx="3566160" cy="3463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pc="-1" dirty="0"/>
              <a:t>Source data related to </a:t>
            </a:r>
          </a:p>
          <a:p>
            <a:pPr algn="ctr"/>
            <a:r>
              <a:rPr lang="en-US" spc="-1" dirty="0"/>
              <a:t>Main </a:t>
            </a:r>
            <a:r>
              <a:rPr lang="en-US" sz="1800" b="0" strike="noStrike" spc="-1" dirty="0">
                <a:latin typeface="Arial"/>
              </a:rPr>
              <a:t>Figure 1d left panel</a:t>
            </a:r>
          </a:p>
        </p:txBody>
      </p:sp>
      <p:cxnSp>
        <p:nvCxnSpPr>
          <p:cNvPr id="4" name="Straight Connector 3"/>
          <p:cNvCxnSpPr/>
          <p:nvPr/>
        </p:nvCxnSpPr>
        <p:spPr>
          <a:xfrm flipH="1">
            <a:off x="1997930" y="1983938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989221" y="2270541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1989221" y="4346810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446650" y="1876216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KDa</a:t>
            </a:r>
            <a:endParaRPr lang="en-IN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1452040" y="2162819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75KDa</a:t>
            </a:r>
            <a:endParaRPr lang="en-IN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1459940" y="4239088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KDa</a:t>
            </a:r>
            <a:endParaRPr lang="en-IN" sz="800" dirty="0"/>
          </a:p>
        </p:txBody>
      </p:sp>
      <p:sp>
        <p:nvSpPr>
          <p:cNvPr id="17" name="TextBox 16"/>
          <p:cNvSpPr txBox="1"/>
          <p:nvPr/>
        </p:nvSpPr>
        <p:spPr>
          <a:xfrm>
            <a:off x="5982855" y="841459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atb2</a:t>
            </a:r>
            <a:r>
              <a:rPr lang="en-US" sz="800" baseline="30000" dirty="0"/>
              <a:t>-/-</a:t>
            </a:r>
            <a:endParaRPr lang="en-IN" sz="800" baseline="30000" dirty="0"/>
          </a:p>
        </p:txBody>
      </p:sp>
      <p:sp>
        <p:nvSpPr>
          <p:cNvPr id="18" name="TextBox 17"/>
          <p:cNvSpPr txBox="1"/>
          <p:nvPr/>
        </p:nvSpPr>
        <p:spPr>
          <a:xfrm>
            <a:off x="6060391" y="3932116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atb2</a:t>
            </a:r>
            <a:r>
              <a:rPr lang="en-US" sz="800" baseline="30000" dirty="0"/>
              <a:t>-/-</a:t>
            </a:r>
            <a:endParaRPr lang="en-IN" sz="800" baseline="30000" dirty="0"/>
          </a:p>
        </p:txBody>
      </p:sp>
      <p:sp>
        <p:nvSpPr>
          <p:cNvPr id="19" name="TextBox 18"/>
          <p:cNvSpPr txBox="1"/>
          <p:nvPr/>
        </p:nvSpPr>
        <p:spPr>
          <a:xfrm>
            <a:off x="5534800" y="841456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ibling</a:t>
            </a:r>
            <a:endParaRPr lang="en-IN" sz="800" baseline="30000" dirty="0"/>
          </a:p>
        </p:txBody>
      </p:sp>
      <p:sp>
        <p:nvSpPr>
          <p:cNvPr id="21" name="TextBox 20"/>
          <p:cNvSpPr txBox="1"/>
          <p:nvPr/>
        </p:nvSpPr>
        <p:spPr>
          <a:xfrm>
            <a:off x="5609421" y="3935568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ibling</a:t>
            </a:r>
            <a:endParaRPr lang="en-IN" sz="800" baseline="30000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93E3E4D-EF64-B54A-8991-3FDAE1350D1D}"/>
              </a:ext>
            </a:extLst>
          </p:cNvPr>
          <p:cNvSpPr/>
          <p:nvPr/>
        </p:nvSpPr>
        <p:spPr>
          <a:xfrm>
            <a:off x="5534800" y="2013584"/>
            <a:ext cx="1043479" cy="3646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7322B47-38C9-CC47-BAD8-AD540917E8B9}"/>
              </a:ext>
            </a:extLst>
          </p:cNvPr>
          <p:cNvSpPr/>
          <p:nvPr/>
        </p:nvSpPr>
        <p:spPr>
          <a:xfrm>
            <a:off x="5637106" y="4216557"/>
            <a:ext cx="1043479" cy="3646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22" name="TextShape 2">
            <a:extLst>
              <a:ext uri="{FF2B5EF4-FFF2-40B4-BE49-F238E27FC236}">
                <a16:creationId xmlns:a16="http://schemas.microsoft.com/office/drawing/2014/main" id="{63B0A25E-647E-7147-93CC-45FEB227D975}"/>
              </a:ext>
            </a:extLst>
          </p:cNvPr>
          <p:cNvSpPr txBox="1"/>
          <p:nvPr/>
        </p:nvSpPr>
        <p:spPr>
          <a:xfrm>
            <a:off x="2056192" y="6225820"/>
            <a:ext cx="5116503" cy="286215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z="1800" b="0" strike="noStrike" spc="-1" dirty="0">
                <a:latin typeface="Arial"/>
              </a:rPr>
              <a:t>Box highlights data represented in Main figure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2"/>
          <p:cNvPicPr/>
          <p:nvPr/>
        </p:nvPicPr>
        <p:blipFill>
          <a:blip r:embed="rId2"/>
          <a:stretch/>
        </p:blipFill>
        <p:spPr>
          <a:xfrm>
            <a:off x="2103480" y="821322"/>
            <a:ext cx="5028840" cy="206136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91" name="Picture 3"/>
          <p:cNvPicPr/>
          <p:nvPr/>
        </p:nvPicPr>
        <p:blipFill>
          <a:blip r:embed="rId3"/>
          <a:stretch/>
        </p:blipFill>
        <p:spPr>
          <a:xfrm>
            <a:off x="1910840" y="3868817"/>
            <a:ext cx="5171545" cy="1679575"/>
          </a:xfrm>
          <a:prstGeom prst="rect">
            <a:avLst/>
          </a:prstGeom>
          <a:solidFill>
            <a:srgbClr val="FFFFFF"/>
          </a:solidFill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92" name="CustomShape 1"/>
          <p:cNvSpPr/>
          <p:nvPr/>
        </p:nvSpPr>
        <p:spPr>
          <a:xfrm>
            <a:off x="6732266" y="1947290"/>
            <a:ext cx="195048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SATB2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93" name="CustomShape 2"/>
          <p:cNvSpPr/>
          <p:nvPr/>
        </p:nvSpPr>
        <p:spPr>
          <a:xfrm>
            <a:off x="6732266" y="4206748"/>
            <a:ext cx="203292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Tubulin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94" name="TextShape 3"/>
          <p:cNvSpPr txBox="1"/>
          <p:nvPr/>
        </p:nvSpPr>
        <p:spPr>
          <a:xfrm>
            <a:off x="2752200" y="6182"/>
            <a:ext cx="3566160" cy="3463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pc="-1" dirty="0"/>
              <a:t>Source data related to </a:t>
            </a:r>
          </a:p>
          <a:p>
            <a:pPr algn="ctr"/>
            <a:r>
              <a:rPr lang="en-US" sz="1800" b="0" strike="noStrike" spc="-1" dirty="0">
                <a:latin typeface="Arial"/>
              </a:rPr>
              <a:t>Main </a:t>
            </a:r>
            <a:r>
              <a:rPr lang="en-US" spc="-1" dirty="0">
                <a:latin typeface="Arial"/>
              </a:rPr>
              <a:t>F</a:t>
            </a:r>
            <a:r>
              <a:rPr lang="en-US" sz="1800" b="0" strike="noStrike" spc="-1" dirty="0">
                <a:latin typeface="Arial"/>
              </a:rPr>
              <a:t>igure 1d right panel</a:t>
            </a:r>
          </a:p>
        </p:txBody>
      </p:sp>
      <p:sp>
        <p:nvSpPr>
          <p:cNvPr id="7" name="Rectangle 6"/>
          <p:cNvSpPr/>
          <p:nvPr/>
        </p:nvSpPr>
        <p:spPr>
          <a:xfrm>
            <a:off x="5297182" y="1965398"/>
            <a:ext cx="993882" cy="2866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5236198" y="4155801"/>
            <a:ext cx="993882" cy="2866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1716980" y="1957811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728149" y="2244414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553034" y="4225147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125943" y="1860364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00KDa</a:t>
            </a:r>
            <a:endParaRPr lang="en-IN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1141273" y="2146967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75KDa</a:t>
            </a:r>
            <a:endParaRPr lang="en-IN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1113204" y="4117425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KDa</a:t>
            </a:r>
            <a:endParaRPr lang="en-IN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5841042" y="647636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atb2</a:t>
            </a:r>
            <a:r>
              <a:rPr lang="en-US" sz="800" baseline="30000" dirty="0"/>
              <a:t>-/-</a:t>
            </a:r>
            <a:endParaRPr lang="en-IN" sz="800" baseline="30000" dirty="0"/>
          </a:p>
        </p:txBody>
      </p:sp>
      <p:sp>
        <p:nvSpPr>
          <p:cNvPr id="16" name="TextBox 15"/>
          <p:cNvSpPr txBox="1"/>
          <p:nvPr/>
        </p:nvSpPr>
        <p:spPr>
          <a:xfrm>
            <a:off x="5294609" y="647634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ibling</a:t>
            </a:r>
            <a:endParaRPr lang="en-IN" sz="800" baseline="30000" dirty="0"/>
          </a:p>
        </p:txBody>
      </p:sp>
      <p:sp>
        <p:nvSpPr>
          <p:cNvPr id="17" name="TextBox 16"/>
          <p:cNvSpPr txBox="1"/>
          <p:nvPr/>
        </p:nvSpPr>
        <p:spPr>
          <a:xfrm>
            <a:off x="5764135" y="3910348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atb2</a:t>
            </a:r>
            <a:r>
              <a:rPr lang="en-US" sz="800" baseline="30000" dirty="0"/>
              <a:t>-/-</a:t>
            </a:r>
            <a:endParaRPr lang="en-IN" sz="800" baseline="30000" dirty="0"/>
          </a:p>
        </p:txBody>
      </p:sp>
      <p:sp>
        <p:nvSpPr>
          <p:cNvPr id="18" name="TextBox 17"/>
          <p:cNvSpPr txBox="1"/>
          <p:nvPr/>
        </p:nvSpPr>
        <p:spPr>
          <a:xfrm>
            <a:off x="5272501" y="3918272"/>
            <a:ext cx="595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i="1" dirty="0"/>
              <a:t>sibling</a:t>
            </a:r>
            <a:endParaRPr lang="en-IN" sz="800" baseline="30000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Picture 2"/>
          <p:cNvPicPr/>
          <p:nvPr/>
        </p:nvPicPr>
        <p:blipFill>
          <a:blip r:embed="rId2"/>
          <a:stretch/>
        </p:blipFill>
        <p:spPr>
          <a:xfrm>
            <a:off x="3474360" y="671881"/>
            <a:ext cx="2012040" cy="338328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96" name="CustomShape 1"/>
          <p:cNvSpPr/>
          <p:nvPr/>
        </p:nvSpPr>
        <p:spPr>
          <a:xfrm>
            <a:off x="5440338" y="2798657"/>
            <a:ext cx="1148760" cy="15465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FLAG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97" name="Picture 3"/>
          <p:cNvPicPr/>
          <p:nvPr/>
        </p:nvPicPr>
        <p:blipFill>
          <a:blip r:embed="rId3"/>
          <a:stretch/>
        </p:blipFill>
        <p:spPr>
          <a:xfrm>
            <a:off x="3291840" y="4431240"/>
            <a:ext cx="2468880" cy="151236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98" name="CustomShape 2"/>
          <p:cNvSpPr/>
          <p:nvPr/>
        </p:nvSpPr>
        <p:spPr>
          <a:xfrm>
            <a:off x="3796200" y="5943600"/>
            <a:ext cx="136836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Tubulin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99" name="TextShape 3"/>
          <p:cNvSpPr txBox="1"/>
          <p:nvPr/>
        </p:nvSpPr>
        <p:spPr>
          <a:xfrm>
            <a:off x="2697300" y="7060"/>
            <a:ext cx="3566160" cy="3463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pc="-1" dirty="0"/>
              <a:t>Source data related to </a:t>
            </a:r>
          </a:p>
          <a:p>
            <a:pPr algn="ctr"/>
            <a:r>
              <a:rPr lang="en-US" sz="1800" b="0" strike="noStrike" spc="-1" dirty="0">
                <a:latin typeface="Arial"/>
              </a:rPr>
              <a:t>Supplementary Figure 5a</a:t>
            </a:r>
          </a:p>
        </p:txBody>
      </p:sp>
      <p:sp>
        <p:nvSpPr>
          <p:cNvPr id="7" name="Rectangle 6"/>
          <p:cNvSpPr/>
          <p:nvPr/>
        </p:nvSpPr>
        <p:spPr>
          <a:xfrm>
            <a:off x="3796200" y="2834887"/>
            <a:ext cx="1487763" cy="3310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8" name="Straight Connector 7"/>
          <p:cNvCxnSpPr/>
          <p:nvPr/>
        </p:nvCxnSpPr>
        <p:spPr>
          <a:xfrm flipH="1">
            <a:off x="3463175" y="2988676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3471301" y="3194990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925994" y="2875987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75KDa</a:t>
            </a:r>
            <a:endParaRPr lang="en-IN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2925994" y="3086600"/>
            <a:ext cx="518011" cy="1958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KDa</a:t>
            </a:r>
            <a:endParaRPr lang="en-IN" sz="800" dirty="0"/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3217393" y="4779989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688112" y="4672267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KDa</a:t>
            </a:r>
            <a:endParaRPr lang="en-IN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3796200" y="1720289"/>
            <a:ext cx="68418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Mock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473706" y="1720289"/>
            <a:ext cx="85362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Satb2 OE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89648" y="4255256"/>
            <a:ext cx="68418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Mock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003378" y="4255256"/>
            <a:ext cx="85362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Satb2 OE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20" name="CustomShape 2">
            <a:extLst>
              <a:ext uri="{FF2B5EF4-FFF2-40B4-BE49-F238E27FC236}">
                <a16:creationId xmlns:a16="http://schemas.microsoft.com/office/drawing/2014/main" id="{1424B430-DABF-6846-9752-5E78AD1979C6}"/>
              </a:ext>
            </a:extLst>
          </p:cNvPr>
          <p:cNvSpPr/>
          <p:nvPr/>
        </p:nvSpPr>
        <p:spPr>
          <a:xfrm>
            <a:off x="5347988" y="4597649"/>
            <a:ext cx="203292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Tubulin</a:t>
            </a:r>
            <a:endParaRPr lang="en-US" sz="18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CustomShape 1"/>
          <p:cNvSpPr/>
          <p:nvPr/>
        </p:nvSpPr>
        <p:spPr>
          <a:xfrm>
            <a:off x="6187538" y="4828674"/>
            <a:ext cx="1545369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Tubulin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101" name="Picture 15"/>
          <p:cNvPicPr/>
          <p:nvPr/>
        </p:nvPicPr>
        <p:blipFill>
          <a:blip r:embed="rId2"/>
          <a:stretch/>
        </p:blipFill>
        <p:spPr>
          <a:xfrm>
            <a:off x="2847600" y="4507920"/>
            <a:ext cx="3096000" cy="196632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pic>
        <p:nvPicPr>
          <p:cNvPr id="102" name="Picture 16"/>
          <p:cNvPicPr/>
          <p:nvPr/>
        </p:nvPicPr>
        <p:blipFill>
          <a:blip r:embed="rId3"/>
          <a:stretch/>
        </p:blipFill>
        <p:spPr>
          <a:xfrm>
            <a:off x="2240280" y="1053360"/>
            <a:ext cx="4160520" cy="2723040"/>
          </a:xfrm>
          <a:prstGeom prst="rect">
            <a:avLst/>
          </a:prstGeom>
          <a:ln>
            <a:solidFill>
              <a:schemeClr val="dk1">
                <a:shade val="95000"/>
                <a:satMod val="105000"/>
              </a:schemeClr>
            </a:solidFill>
          </a:ln>
        </p:spPr>
      </p:pic>
      <p:sp>
        <p:nvSpPr>
          <p:cNvPr id="103" name="CustomShape 2"/>
          <p:cNvSpPr/>
          <p:nvPr/>
        </p:nvSpPr>
        <p:spPr>
          <a:xfrm>
            <a:off x="4617900" y="1997808"/>
            <a:ext cx="457164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en-US" sz="1800" b="0" strike="noStrike" spc="-1" dirty="0">
                <a:solidFill>
                  <a:srgbClr val="000000"/>
                </a:solidFill>
                <a:latin typeface="Calibri"/>
              </a:rPr>
              <a:t>IB: FLAG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104" name="TextShape 3"/>
          <p:cNvSpPr txBox="1"/>
          <p:nvPr/>
        </p:nvSpPr>
        <p:spPr>
          <a:xfrm>
            <a:off x="2512194" y="0"/>
            <a:ext cx="3566160" cy="34632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/>
            <a:r>
              <a:rPr lang="en-US" spc="-1" dirty="0"/>
              <a:t>Source data related </a:t>
            </a:r>
            <a:r>
              <a:rPr lang="en-US" sz="1800" b="0" strike="noStrike" spc="-1" dirty="0">
                <a:latin typeface="Arial"/>
              </a:rPr>
              <a:t>Supplementary Figure 7a</a:t>
            </a:r>
          </a:p>
        </p:txBody>
      </p:sp>
      <p:sp>
        <p:nvSpPr>
          <p:cNvPr id="7" name="Rectangle 6"/>
          <p:cNvSpPr/>
          <p:nvPr/>
        </p:nvSpPr>
        <p:spPr>
          <a:xfrm>
            <a:off x="4571999" y="2085474"/>
            <a:ext cx="435521" cy="2973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5486399" y="2085474"/>
            <a:ext cx="435521" cy="2973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 8"/>
          <p:cNvSpPr/>
          <p:nvPr/>
        </p:nvSpPr>
        <p:spPr>
          <a:xfrm>
            <a:off x="3128212" y="4828674"/>
            <a:ext cx="609600" cy="3689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0" name="Rectangle 9"/>
          <p:cNvSpPr/>
          <p:nvPr/>
        </p:nvSpPr>
        <p:spPr>
          <a:xfrm>
            <a:off x="4295274" y="4828674"/>
            <a:ext cx="609600" cy="3689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TextBox 10"/>
          <p:cNvSpPr txBox="1"/>
          <p:nvPr/>
        </p:nvSpPr>
        <p:spPr>
          <a:xfrm>
            <a:off x="4390794" y="786622"/>
            <a:ext cx="68418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CNT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177484" y="786622"/>
            <a:ext cx="101005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FLAG Satb2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06137" y="4294598"/>
            <a:ext cx="684180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CNT</a:t>
            </a:r>
            <a:endParaRPr lang="en-IN" sz="1600" baseline="30000" dirty="0">
              <a:latin typeface="+mj-lt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083897" y="4284659"/>
            <a:ext cx="101005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aseline="30000" dirty="0">
                <a:latin typeface="+mj-lt"/>
              </a:rPr>
              <a:t>FLAG Satb2</a:t>
            </a:r>
            <a:endParaRPr lang="en-IN" sz="1600" baseline="30000" dirty="0">
              <a:latin typeface="+mj-lt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H="1">
            <a:off x="1948274" y="2147709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493114" y="4997904"/>
            <a:ext cx="31729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411093" y="2039987"/>
            <a:ext cx="775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75KDa</a:t>
            </a:r>
            <a:endParaRPr lang="en-IN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1947807" y="4879721"/>
            <a:ext cx="5180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0KDa</a:t>
            </a:r>
            <a:endParaRPr lang="en-IN" sz="800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</TotalTime>
  <Words>123</Words>
  <Application>Microsoft Macintosh PowerPoint</Application>
  <PresentationFormat>On-screen Show (4:3)</PresentationFormat>
  <Paragraphs>5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Symbol</vt:lpstr>
      <vt:lpstr>Times New Roman</vt:lpstr>
      <vt:lpstr>Wingdings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kita Sharma</dc:creator>
  <dc:description/>
  <cp:lastModifiedBy>Pradhan,Saurabh Jagdish</cp:lastModifiedBy>
  <cp:revision>13</cp:revision>
  <dcterms:created xsi:type="dcterms:W3CDTF">2021-08-26T16:19:27Z</dcterms:created>
  <dcterms:modified xsi:type="dcterms:W3CDTF">2021-08-28T14:13:52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5</vt:i4>
  </property>
</Properties>
</file>